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6" r:id="rId3"/>
    <p:sldId id="257" r:id="rId4"/>
    <p:sldId id="258" r:id="rId5"/>
    <p:sldId id="259" r:id="rId6"/>
    <p:sldId id="261" r:id="rId7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40" d="100"/>
          <a:sy n="40" d="100"/>
        </p:scale>
        <p:origin x="926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1023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3345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45752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7051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>
                    <a:tint val="82000"/>
                  </a:schemeClr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82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2066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15591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1068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1537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8243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9373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4169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94DF87-06A4-496B-BF53-DBD60C31B6F7}" type="datetimeFigureOut">
              <a:rPr lang="en-CA" smtClean="0"/>
              <a:t>2025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F046A3-DD04-474E-8555-E0E041259F1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61469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20CDF85-DB1F-98C7-9FA2-26BDF77D1C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648970"/>
            <a:ext cx="16256000" cy="812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CF003F7-6423-D5E6-AA7E-A05065B71D81}"/>
              </a:ext>
            </a:extLst>
          </p:cNvPr>
          <p:cNvSpPr txBox="1"/>
          <p:nvPr/>
        </p:nvSpPr>
        <p:spPr>
          <a:xfrm>
            <a:off x="1585383" y="9348470"/>
            <a:ext cx="14325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latin typeface="Times New Roman" panose="02020603050405020304" pitchFamily="18" charset="0"/>
                <a:ea typeface="Aptos" panose="020B0004020202020204" pitchFamily="34" charset="0"/>
              </a:rPr>
              <a:t>Figure S1. Boxplots of the total length (in millimetres, A) and weight (in grams, B) of all the sampled specimens, separated into sampling regions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998316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7878867-5406-8532-D74A-08F169216C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91615" y="99536"/>
            <a:ext cx="9567969" cy="112564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CA286FE-21E7-B224-6AD9-0B11D8F218EA}"/>
              </a:ext>
            </a:extLst>
          </p:cNvPr>
          <p:cNvSpPr txBox="1"/>
          <p:nvPr/>
        </p:nvSpPr>
        <p:spPr>
          <a:xfrm>
            <a:off x="965200" y="11355970"/>
            <a:ext cx="143255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latin typeface="Times New Roman" panose="02020603050405020304" pitchFamily="18" charset="0"/>
                <a:ea typeface="Aptos" panose="020B0004020202020204" pitchFamily="34" charset="0"/>
              </a:rPr>
              <a:t>Figure S2: Visualization of the total reads detected per individual sample in the species dataset, grouped and coloured according to region (A, ENL; B, SNL; C, CB; D, </a:t>
            </a:r>
            <a:r>
              <a:rPr lang="en-CA" dirty="0" err="1">
                <a:latin typeface="Times New Roman" panose="02020603050405020304" pitchFamily="18" charset="0"/>
                <a:ea typeface="Aptos" panose="020B0004020202020204" pitchFamily="34" charset="0"/>
              </a:rPr>
              <a:t>ScNS</a:t>
            </a:r>
            <a:r>
              <a:rPr lang="en-CA" dirty="0">
                <a:latin typeface="Times New Roman" panose="02020603050405020304" pitchFamily="18" charset="0"/>
                <a:ea typeface="Aptos" panose="020B0004020202020204" pitchFamily="34" charset="0"/>
              </a:rPr>
              <a:t>, E, </a:t>
            </a:r>
            <a:r>
              <a:rPr lang="en-CA" dirty="0" err="1">
                <a:latin typeface="Times New Roman" panose="02020603050405020304" pitchFamily="18" charset="0"/>
                <a:ea typeface="Aptos" panose="020B0004020202020204" pitchFamily="34" charset="0"/>
              </a:rPr>
              <a:t>SwNS</a:t>
            </a:r>
            <a:r>
              <a:rPr lang="en-CA" dirty="0">
                <a:latin typeface="Times New Roman" panose="02020603050405020304" pitchFamily="18" charset="0"/>
                <a:ea typeface="Aptos" panose="020B0004020202020204" pitchFamily="34" charset="0"/>
              </a:rPr>
              <a:t>)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6346035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A896AD2-D1AD-F30C-C10C-98CE60B58BFA}"/>
              </a:ext>
            </a:extLst>
          </p:cNvPr>
          <p:cNvSpPr txBox="1"/>
          <p:nvPr/>
        </p:nvSpPr>
        <p:spPr>
          <a:xfrm>
            <a:off x="660400" y="8778240"/>
            <a:ext cx="14935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igure S3: Visualization of the detected reads per primer for the top 10 most common taxa by total read count. A: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Ophiopholis aculeata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B: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Amphibalanus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improvisus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C: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ytilus trossulus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D: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etridium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senile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E: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onocorophium insidiosum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F: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Halocladius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variabilis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G: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Lacuna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vincta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H: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Gammarus oceanicus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I: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Harmothoe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imbricata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, J: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Bittiolum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</a:t>
            </a:r>
            <a:r>
              <a:rPr lang="en-CA" sz="1800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varium</a:t>
            </a:r>
            <a:r>
              <a:rPr lang="en-C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.</a:t>
            </a:r>
            <a:endParaRPr lang="en-CA" dirty="0"/>
          </a:p>
        </p:txBody>
      </p:sp>
      <p:pic>
        <p:nvPicPr>
          <p:cNvPr id="7" name="Picture 6" descr="A group of colored rectangles&#10;&#10;AI-generated content may be incorrect.">
            <a:extLst>
              <a:ext uri="{FF2B5EF4-FFF2-40B4-BE49-F238E27FC236}">
                <a16:creationId xmlns:a16="http://schemas.microsoft.com/office/drawing/2014/main" id="{04BD0C8C-2B86-3746-AA11-12F586B929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0" y="655320"/>
            <a:ext cx="16245840" cy="8122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03410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95135365-0DD1-03C2-AA72-22A1BA48006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30261" y="142083"/>
            <a:ext cx="10881518" cy="1088151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FDC130-AFB1-316C-ACD8-781FD34EF975}"/>
              </a:ext>
            </a:extLst>
          </p:cNvPr>
          <p:cNvSpPr txBox="1"/>
          <p:nvPr/>
        </p:nvSpPr>
        <p:spPr>
          <a:xfrm>
            <a:off x="1203960" y="11203251"/>
            <a:ext cx="15866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igure S4: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PCoA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</a:rPr>
              <a:t>generated from a distance matrix calculated through Sorensen’s coefficient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with regional colour overlay for the morphological dataset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170358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E78DE2B-089E-9851-18FE-AEFFEA6F20F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2287184"/>
            <a:ext cx="16256000" cy="5618566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4534F6A-351D-1C51-7750-B672E03F0330}"/>
              </a:ext>
            </a:extLst>
          </p:cNvPr>
          <p:cNvSpPr txBox="1"/>
          <p:nvPr/>
        </p:nvSpPr>
        <p:spPr>
          <a:xfrm>
            <a:off x="988483" y="8824807"/>
            <a:ext cx="150223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igure S5: PCoAs generated from a distance matrix calculated using Sorensen’s coefficient on a presence/absence dataset, with year-based shape overlay for the species (A)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</a:rPr>
              <a:t> and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genus (B) metabarcode datasets, as well as the morphological (C) dataset. Datapoints represent samples from a single site (HBW) that was sampl</a:t>
            </a:r>
            <a:r>
              <a:rPr lang="en-US" dirty="0">
                <a:latin typeface="Times New Roman" panose="02020603050405020304" pitchFamily="18" charset="0"/>
                <a:ea typeface="Aptos" panose="020B0004020202020204" pitchFamily="34" charset="0"/>
              </a:rPr>
              <a:t>ed over multiple years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4242951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6EBB2E1-B1FA-0FC1-9BA5-1B418C1340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18440" y="1328428"/>
            <a:ext cx="15859760" cy="79298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34A53BE-32C2-5378-5089-CBD2E5F6BDDE}"/>
              </a:ext>
            </a:extLst>
          </p:cNvPr>
          <p:cNvSpPr txBox="1"/>
          <p:nvPr/>
        </p:nvSpPr>
        <p:spPr>
          <a:xfrm>
            <a:off x="616821" y="9258308"/>
            <a:ext cx="15022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igure S6: Percent frequency of occurrence (%FOO) of the top 20 most identified taxa within the metabarcode-species filtered dataset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90882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4</TotalTime>
  <Words>259</Words>
  <Application>Microsoft Office PowerPoint</Application>
  <PresentationFormat>Custom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 Bender</dc:creator>
  <cp:lastModifiedBy>Chris Bender</cp:lastModifiedBy>
  <cp:revision>18</cp:revision>
  <dcterms:created xsi:type="dcterms:W3CDTF">2024-11-11T21:27:33Z</dcterms:created>
  <dcterms:modified xsi:type="dcterms:W3CDTF">2025-02-08T20:26:51Z</dcterms:modified>
</cp:coreProperties>
</file>